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9" r:id="rId2"/>
    <p:sldId id="260" r:id="rId3"/>
  </p:sldIdLst>
  <p:sldSz cx="12252325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9" d="100"/>
          <a:sy n="79" d="100"/>
        </p:scale>
        <p:origin x="181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cap="none" spc="0" normalizeH="0" baseline="0">
                <a:solidFill>
                  <a:sysClr val="windowText" lastClr="000000"/>
                </a:solidFill>
                <a:latin typeface="+mj-lt"/>
                <a:ea typeface="+mj-ea"/>
                <a:cs typeface="+mj-cs"/>
              </a:defRPr>
            </a:pPr>
            <a:r>
              <a:rPr lang="en-US" sz="1400" b="1" i="0" baseline="0">
                <a:effectLst/>
              </a:rPr>
              <a:t>Up-regulated genes in RTx2911 after inocculation</a:t>
            </a:r>
            <a:endParaRPr lang="en-US" sz="140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0" normalizeH="0" baseline="0">
              <a:solidFill>
                <a:sysClr val="windowText" lastClr="000000"/>
              </a:solidFill>
              <a:latin typeface="+mj-lt"/>
              <a:ea typeface="+mj-ea"/>
              <a:cs typeface="+mj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Biological_RTx2911!$F$4:$F$22</c:f>
              <c:strCache>
                <c:ptCount val="19"/>
                <c:pt idx="0">
                  <c:v>Organonitrogen compound metabolism</c:v>
                </c:pt>
                <c:pt idx="1">
                  <c:v>Cell wall degradation</c:v>
                </c:pt>
                <c:pt idx="2">
                  <c:v>Response to inorganic substance </c:v>
                </c:pt>
                <c:pt idx="3">
                  <c:v>Flavonoid biosynthetic process </c:v>
                </c:pt>
                <c:pt idx="4">
                  <c:v>Response to chitin </c:v>
                </c:pt>
                <c:pt idx="5">
                  <c:v>Transmembrane transport </c:v>
                </c:pt>
                <c:pt idx="6">
                  <c:v>Phenylpropanoid metabolism</c:v>
                </c:pt>
                <c:pt idx="7">
                  <c:v>Response to abiotic stimulus </c:v>
                </c:pt>
                <c:pt idx="8">
                  <c:v>Aromatic compound catabolism</c:v>
                </c:pt>
                <c:pt idx="9">
                  <c:v>Organic cyclic compound catabolism</c:v>
                </c:pt>
                <c:pt idx="10">
                  <c:v>Defense response </c:v>
                </c:pt>
                <c:pt idx="11">
                  <c:v>Amino acid family metabolism</c:v>
                </c:pt>
                <c:pt idx="12">
                  <c:v>Secondary metabolite biosynthesis</c:v>
                </c:pt>
                <c:pt idx="13">
                  <c:v>Response to biotic stimulus </c:v>
                </c:pt>
                <c:pt idx="14">
                  <c:v>Drug catabolic process </c:v>
                </c:pt>
                <c:pt idx="15">
                  <c:v>Carbohydrate metabolic process </c:v>
                </c:pt>
                <c:pt idx="16">
                  <c:v>Response to stress </c:v>
                </c:pt>
                <c:pt idx="17">
                  <c:v>Response to stimulus </c:v>
                </c:pt>
                <c:pt idx="18">
                  <c:v>Oxidation-reduction process </c:v>
                </c:pt>
              </c:strCache>
            </c:strRef>
          </c:cat>
          <c:val>
            <c:numRef>
              <c:f>Biological_RTx2911!$G$4:$G$22</c:f>
              <c:numCache>
                <c:formatCode>General</c:formatCode>
                <c:ptCount val="19"/>
                <c:pt idx="0">
                  <c:v>129</c:v>
                </c:pt>
                <c:pt idx="1">
                  <c:v>4</c:v>
                </c:pt>
                <c:pt idx="2">
                  <c:v>14</c:v>
                </c:pt>
                <c:pt idx="3">
                  <c:v>4</c:v>
                </c:pt>
                <c:pt idx="4">
                  <c:v>3</c:v>
                </c:pt>
                <c:pt idx="5">
                  <c:v>43</c:v>
                </c:pt>
                <c:pt idx="6">
                  <c:v>8</c:v>
                </c:pt>
                <c:pt idx="7">
                  <c:v>29</c:v>
                </c:pt>
                <c:pt idx="8">
                  <c:v>16</c:v>
                </c:pt>
                <c:pt idx="9">
                  <c:v>17</c:v>
                </c:pt>
                <c:pt idx="10">
                  <c:v>24</c:v>
                </c:pt>
                <c:pt idx="11">
                  <c:v>10</c:v>
                </c:pt>
                <c:pt idx="12">
                  <c:v>16</c:v>
                </c:pt>
                <c:pt idx="13">
                  <c:v>19</c:v>
                </c:pt>
                <c:pt idx="14">
                  <c:v>22</c:v>
                </c:pt>
                <c:pt idx="15">
                  <c:v>45</c:v>
                </c:pt>
                <c:pt idx="16">
                  <c:v>62</c:v>
                </c:pt>
                <c:pt idx="17">
                  <c:v>101</c:v>
                </c:pt>
                <c:pt idx="18">
                  <c:v>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7B3-4457-ACE7-F551EF93CA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9"/>
        <c:axId val="265863664"/>
        <c:axId val="265860056"/>
      </c:barChart>
      <c:catAx>
        <c:axId val="2658636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cap="none" spc="0" normalizeH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5860056"/>
        <c:crosses val="autoZero"/>
        <c:auto val="1"/>
        <c:lblAlgn val="ctr"/>
        <c:lblOffset val="100"/>
        <c:noMultiLvlLbl val="0"/>
      </c:catAx>
      <c:valAx>
        <c:axId val="26586005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cap="none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cap="none" baseline="0">
                    <a:solidFill>
                      <a:sysClr val="windowText" lastClr="000000"/>
                    </a:solidFill>
                  </a:rPr>
                  <a:t>Number of gen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cap="none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5863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cap="none" spc="0" normalizeH="0" baseline="0">
                <a:solidFill>
                  <a:sysClr val="windowText" lastClr="000000"/>
                </a:solidFill>
                <a:latin typeface="+mj-lt"/>
                <a:ea typeface="+mj-ea"/>
                <a:cs typeface="+mj-cs"/>
              </a:defRPr>
            </a:pPr>
            <a:r>
              <a:rPr lang="en-US" sz="1400" b="1" i="0" baseline="0">
                <a:effectLst/>
              </a:rPr>
              <a:t>Up-regulated genes in RTx430 after inocculation</a:t>
            </a:r>
            <a:endParaRPr lang="en-US" sz="140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0" normalizeH="0" baseline="0">
              <a:solidFill>
                <a:sysClr val="windowText" lastClr="000000"/>
              </a:solidFill>
              <a:latin typeface="+mj-lt"/>
              <a:ea typeface="+mj-ea"/>
              <a:cs typeface="+mj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Biological_RTx430!$E$3:$E$19</c:f>
              <c:strCache>
                <c:ptCount val="17"/>
                <c:pt idx="0">
                  <c:v>Cell redox homeostasis </c:v>
                </c:pt>
                <c:pt idx="1">
                  <c:v>Regulation of carbohydrate metabolism</c:v>
                </c:pt>
                <c:pt idx="2">
                  <c:v>Defense response </c:v>
                </c:pt>
                <c:pt idx="3">
                  <c:v>Organonitrogen compound metabolism</c:v>
                </c:pt>
                <c:pt idx="4">
                  <c:v>Cellular metabolic compound salvage </c:v>
                </c:pt>
                <c:pt idx="5">
                  <c:v>Secondary metabolic process </c:v>
                </c:pt>
                <c:pt idx="6">
                  <c:v>Oxidation-reduction process </c:v>
                </c:pt>
                <c:pt idx="7">
                  <c:v>Inhibition of hydrolase activity</c:v>
                </c:pt>
                <c:pt idx="8">
                  <c:v>Phosphorus metabolic process </c:v>
                </c:pt>
                <c:pt idx="9">
                  <c:v>Phosphorylation </c:v>
                </c:pt>
                <c:pt idx="10">
                  <c:v>Carbohydrate metabolic process </c:v>
                </c:pt>
                <c:pt idx="11">
                  <c:v>Response to biotic stimulus </c:v>
                </c:pt>
                <c:pt idx="12">
                  <c:v>Cellular homeostasis </c:v>
                </c:pt>
                <c:pt idx="13">
                  <c:v>Amino acid metabolic process </c:v>
                </c:pt>
                <c:pt idx="14">
                  <c:v>Drug metabolic process </c:v>
                </c:pt>
                <c:pt idx="15">
                  <c:v>Small molecule metabolism</c:v>
                </c:pt>
                <c:pt idx="16">
                  <c:v>Catabolic process </c:v>
                </c:pt>
              </c:strCache>
            </c:strRef>
          </c:cat>
          <c:val>
            <c:numRef>
              <c:f>Biological_RTx430!$F$3:$F$19</c:f>
              <c:numCache>
                <c:formatCode>General</c:formatCode>
                <c:ptCount val="17"/>
                <c:pt idx="0">
                  <c:v>5</c:v>
                </c:pt>
                <c:pt idx="1">
                  <c:v>2</c:v>
                </c:pt>
                <c:pt idx="2">
                  <c:v>10</c:v>
                </c:pt>
                <c:pt idx="3">
                  <c:v>67</c:v>
                </c:pt>
                <c:pt idx="4">
                  <c:v>3</c:v>
                </c:pt>
                <c:pt idx="5">
                  <c:v>8</c:v>
                </c:pt>
                <c:pt idx="6">
                  <c:v>32</c:v>
                </c:pt>
                <c:pt idx="7">
                  <c:v>5</c:v>
                </c:pt>
                <c:pt idx="8">
                  <c:v>38</c:v>
                </c:pt>
                <c:pt idx="9">
                  <c:v>30</c:v>
                </c:pt>
                <c:pt idx="10">
                  <c:v>21</c:v>
                </c:pt>
                <c:pt idx="11">
                  <c:v>9</c:v>
                </c:pt>
                <c:pt idx="12">
                  <c:v>10</c:v>
                </c:pt>
                <c:pt idx="13">
                  <c:v>10</c:v>
                </c:pt>
                <c:pt idx="14">
                  <c:v>19</c:v>
                </c:pt>
                <c:pt idx="15">
                  <c:v>31</c:v>
                </c:pt>
                <c:pt idx="16">
                  <c:v>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1B7-405C-9AA6-3B82BCDD55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9"/>
        <c:axId val="328320256"/>
        <c:axId val="279155992"/>
      </c:barChart>
      <c:catAx>
        <c:axId val="3283202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cap="none" spc="0" normalizeH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9155992"/>
        <c:crosses val="autoZero"/>
        <c:auto val="1"/>
        <c:lblAlgn val="ctr"/>
        <c:lblOffset val="100"/>
        <c:noMultiLvlLbl val="0"/>
      </c:catAx>
      <c:valAx>
        <c:axId val="2791559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cap="none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cap="none" baseline="0">
                    <a:solidFill>
                      <a:sysClr val="windowText" lastClr="000000"/>
                    </a:solidFill>
                  </a:rPr>
                  <a:t>Number of gen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cap="none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83202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cap="none" spc="0" normalizeH="0" baseline="0">
                <a:solidFill>
                  <a:sysClr val="windowText" lastClr="000000"/>
                </a:solidFill>
                <a:latin typeface="+mj-lt"/>
                <a:ea typeface="+mj-ea"/>
                <a:cs typeface="+mj-cs"/>
              </a:defRPr>
            </a:pPr>
            <a:r>
              <a:rPr lang="en-US" sz="1400" b="1" i="0" baseline="0">
                <a:effectLst/>
              </a:rPr>
              <a:t>Down-regulated genes in RTx2911 after inocculation</a:t>
            </a:r>
            <a:endParaRPr lang="en-US" sz="140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0" normalizeH="0" baseline="0">
              <a:solidFill>
                <a:sysClr val="windowText" lastClr="000000"/>
              </a:solidFill>
              <a:latin typeface="+mj-lt"/>
              <a:ea typeface="+mj-ea"/>
              <a:cs typeface="+mj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Biological_RTx2911!$N$5:$N$19</c:f>
              <c:strCache>
                <c:ptCount val="15"/>
                <c:pt idx="0">
                  <c:v>Amino acid metabolic process </c:v>
                </c:pt>
                <c:pt idx="1">
                  <c:v>Small molecule biosynthesis</c:v>
                </c:pt>
                <c:pt idx="2">
                  <c:v>Carbohydrate metabolic process </c:v>
                </c:pt>
                <c:pt idx="3">
                  <c:v>Carboxylic acid metabolic process </c:v>
                </c:pt>
                <c:pt idx="4">
                  <c:v>DNA replication </c:v>
                </c:pt>
                <c:pt idx="5">
                  <c:v>Gene expression </c:v>
                </c:pt>
                <c:pt idx="6">
                  <c:v>DNA conformation change </c:v>
                </c:pt>
                <c:pt idx="7">
                  <c:v>Organonitrogen compound biosynthesis</c:v>
                </c:pt>
                <c:pt idx="8">
                  <c:v>Cellular biosynthetic process </c:v>
                </c:pt>
                <c:pt idx="9">
                  <c:v>Maturation of SSU-rRNA </c:v>
                </c:pt>
                <c:pt idx="10">
                  <c:v>DNA metabolic process </c:v>
                </c:pt>
                <c:pt idx="11">
                  <c:v>Cellular component biogenesis </c:v>
                </c:pt>
                <c:pt idx="12">
                  <c:v>RNA processing </c:v>
                </c:pt>
                <c:pt idx="13">
                  <c:v>Cellular nitrogen compound metabolism</c:v>
                </c:pt>
                <c:pt idx="14">
                  <c:v>Starch metabolic process </c:v>
                </c:pt>
              </c:strCache>
            </c:strRef>
          </c:cat>
          <c:val>
            <c:numRef>
              <c:f>Biological_RTx2911!$O$5:$O$19</c:f>
              <c:numCache>
                <c:formatCode>General</c:formatCode>
                <c:ptCount val="15"/>
                <c:pt idx="0">
                  <c:v>7</c:v>
                </c:pt>
                <c:pt idx="1">
                  <c:v>9</c:v>
                </c:pt>
                <c:pt idx="2">
                  <c:v>14</c:v>
                </c:pt>
                <c:pt idx="3">
                  <c:v>12</c:v>
                </c:pt>
                <c:pt idx="4">
                  <c:v>5</c:v>
                </c:pt>
                <c:pt idx="5">
                  <c:v>37</c:v>
                </c:pt>
                <c:pt idx="6">
                  <c:v>5</c:v>
                </c:pt>
                <c:pt idx="7">
                  <c:v>21</c:v>
                </c:pt>
                <c:pt idx="8">
                  <c:v>50</c:v>
                </c:pt>
                <c:pt idx="9">
                  <c:v>4</c:v>
                </c:pt>
                <c:pt idx="10">
                  <c:v>11</c:v>
                </c:pt>
                <c:pt idx="11">
                  <c:v>29</c:v>
                </c:pt>
                <c:pt idx="12">
                  <c:v>15</c:v>
                </c:pt>
                <c:pt idx="13">
                  <c:v>56</c:v>
                </c:pt>
                <c:pt idx="14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53A-4FE9-9BB8-7607C94AD6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9"/>
        <c:axId val="318536936"/>
        <c:axId val="318536608"/>
      </c:barChart>
      <c:catAx>
        <c:axId val="3185369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cap="none" spc="0" normalizeH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8536608"/>
        <c:crosses val="autoZero"/>
        <c:auto val="1"/>
        <c:lblAlgn val="ctr"/>
        <c:lblOffset val="100"/>
        <c:noMultiLvlLbl val="0"/>
      </c:catAx>
      <c:valAx>
        <c:axId val="31853660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cap="none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cap="none" baseline="0">
                    <a:solidFill>
                      <a:sysClr val="windowText" lastClr="000000"/>
                    </a:solidFill>
                  </a:rPr>
                  <a:t>Number of gen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cap="none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85369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cap="none" spc="0" normalizeH="0" baseline="0">
                <a:solidFill>
                  <a:sysClr val="windowText" lastClr="000000"/>
                </a:solidFill>
                <a:latin typeface="+mj-lt"/>
                <a:ea typeface="+mj-ea"/>
                <a:cs typeface="+mj-cs"/>
              </a:defRPr>
            </a:pPr>
            <a:r>
              <a:rPr lang="en-US" sz="1400" b="1" i="0" baseline="0">
                <a:effectLst/>
              </a:rPr>
              <a:t>Down-regulated genes in RTx430 after inocculation</a:t>
            </a:r>
            <a:endParaRPr lang="en-US" sz="140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0" normalizeH="0" baseline="0">
              <a:solidFill>
                <a:sysClr val="windowText" lastClr="000000"/>
              </a:solidFill>
              <a:latin typeface="+mj-lt"/>
              <a:ea typeface="+mj-ea"/>
              <a:cs typeface="+mj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9544378827646542"/>
          <c:y val="0.13482153948135941"/>
          <c:w val="0.5613339895013123"/>
          <c:h val="0.71911280069471117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Biological_RTx430!$N$3:$N$20</c:f>
              <c:strCache>
                <c:ptCount val="18"/>
                <c:pt idx="0">
                  <c:v>DNA recombination </c:v>
                </c:pt>
                <c:pt idx="1">
                  <c:v>Cell proliferation </c:v>
                </c:pt>
                <c:pt idx="2">
                  <c:v>Carbohydrate metabolism</c:v>
                </c:pt>
                <c:pt idx="3">
                  <c:v>Chromatin assembly </c:v>
                </c:pt>
                <c:pt idx="4">
                  <c:v>DNA replication initiation </c:v>
                </c:pt>
                <c:pt idx="5">
                  <c:v>Cellular glycan metabolism</c:v>
                </c:pt>
                <c:pt idx="6">
                  <c:v>SnRNA metabolic process </c:v>
                </c:pt>
                <c:pt idx="7">
                  <c:v>Glucan metabolic process </c:v>
                </c:pt>
                <c:pt idx="8">
                  <c:v>Glycogen metabolic process </c:v>
                </c:pt>
                <c:pt idx="9">
                  <c:v>Small molecule biosynthesis</c:v>
                </c:pt>
                <c:pt idx="10">
                  <c:v>Organic acid biosynthetic process </c:v>
                </c:pt>
                <c:pt idx="11">
                  <c:v>DNA conformation change </c:v>
                </c:pt>
                <c:pt idx="12">
                  <c:v>Secondary metabolite biosynthesis</c:v>
                </c:pt>
                <c:pt idx="13">
                  <c:v>Oxidation-reduction process </c:v>
                </c:pt>
                <c:pt idx="14">
                  <c:v>Small molecule metabolism</c:v>
                </c:pt>
                <c:pt idx="15">
                  <c:v>Cellular biosynthetic process </c:v>
                </c:pt>
                <c:pt idx="16">
                  <c:v>Organic substance biosynthesis</c:v>
                </c:pt>
                <c:pt idx="17">
                  <c:v>Biosynthetic process </c:v>
                </c:pt>
              </c:strCache>
            </c:strRef>
          </c:cat>
          <c:val>
            <c:numRef>
              <c:f>Biological_RTx430!$O$3:$O$20</c:f>
              <c:numCache>
                <c:formatCode>General</c:formatCode>
                <c:ptCount val="18"/>
                <c:pt idx="0">
                  <c:v>5</c:v>
                </c:pt>
                <c:pt idx="1">
                  <c:v>3</c:v>
                </c:pt>
                <c:pt idx="2">
                  <c:v>19</c:v>
                </c:pt>
                <c:pt idx="3">
                  <c:v>4</c:v>
                </c:pt>
                <c:pt idx="4">
                  <c:v>3</c:v>
                </c:pt>
                <c:pt idx="5">
                  <c:v>8</c:v>
                </c:pt>
                <c:pt idx="6">
                  <c:v>3</c:v>
                </c:pt>
                <c:pt idx="7">
                  <c:v>8</c:v>
                </c:pt>
                <c:pt idx="8">
                  <c:v>3</c:v>
                </c:pt>
                <c:pt idx="9">
                  <c:v>15</c:v>
                </c:pt>
                <c:pt idx="10">
                  <c:v>13</c:v>
                </c:pt>
                <c:pt idx="11">
                  <c:v>7</c:v>
                </c:pt>
                <c:pt idx="12">
                  <c:v>9</c:v>
                </c:pt>
                <c:pt idx="13">
                  <c:v>37</c:v>
                </c:pt>
                <c:pt idx="14">
                  <c:v>30</c:v>
                </c:pt>
                <c:pt idx="15">
                  <c:v>70</c:v>
                </c:pt>
                <c:pt idx="16">
                  <c:v>74</c:v>
                </c:pt>
                <c:pt idx="17">
                  <c:v>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CA9-4201-AABD-0EA449533E8E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69"/>
        <c:axId val="336638088"/>
        <c:axId val="336638416"/>
      </c:barChart>
      <c:catAx>
        <c:axId val="3366380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cap="none" spc="0" normalizeH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6638416"/>
        <c:crosses val="autoZero"/>
        <c:auto val="1"/>
        <c:lblAlgn val="ctr"/>
        <c:lblOffset val="100"/>
        <c:noMultiLvlLbl val="0"/>
      </c:catAx>
      <c:valAx>
        <c:axId val="33663841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cap="none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cap="none" baseline="0">
                    <a:solidFill>
                      <a:sysClr val="windowText" lastClr="000000"/>
                    </a:solidFill>
                  </a:rPr>
                  <a:t>Number of gen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cap="none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66380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0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2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0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2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0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2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0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8925" y="1646133"/>
            <a:ext cx="10414476" cy="3501813"/>
          </a:xfrm>
        </p:spPr>
        <p:txBody>
          <a:bodyPr anchor="b"/>
          <a:lstStyle>
            <a:lvl1pPr algn="ctr">
              <a:defRPr sz="80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31541" y="5282989"/>
            <a:ext cx="9189244" cy="2428451"/>
          </a:xfrm>
        </p:spPr>
        <p:txBody>
          <a:bodyPr/>
          <a:lstStyle>
            <a:lvl1pPr marL="0" indent="0" algn="ctr">
              <a:buNone/>
              <a:defRPr sz="3216"/>
            </a:lvl1pPr>
            <a:lvl2pPr marL="612602" indent="0" algn="ctr">
              <a:buNone/>
              <a:defRPr sz="2680"/>
            </a:lvl2pPr>
            <a:lvl3pPr marL="1225205" indent="0" algn="ctr">
              <a:buNone/>
              <a:defRPr sz="2412"/>
            </a:lvl3pPr>
            <a:lvl4pPr marL="1837807" indent="0" algn="ctr">
              <a:buNone/>
              <a:defRPr sz="2144"/>
            </a:lvl4pPr>
            <a:lvl5pPr marL="2450409" indent="0" algn="ctr">
              <a:buNone/>
              <a:defRPr sz="2144"/>
            </a:lvl5pPr>
            <a:lvl6pPr marL="3063011" indent="0" algn="ctr">
              <a:buNone/>
              <a:defRPr sz="2144"/>
            </a:lvl6pPr>
            <a:lvl7pPr marL="3675614" indent="0" algn="ctr">
              <a:buNone/>
              <a:defRPr sz="2144"/>
            </a:lvl7pPr>
            <a:lvl8pPr marL="4288216" indent="0" algn="ctr">
              <a:buNone/>
              <a:defRPr sz="2144"/>
            </a:lvl8pPr>
            <a:lvl9pPr marL="4900818" indent="0" algn="ctr">
              <a:buNone/>
              <a:defRPr sz="214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3108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0147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68071" y="535517"/>
            <a:ext cx="2641908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42348" y="535517"/>
            <a:ext cx="7772569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5661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9785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5967" y="2507618"/>
            <a:ext cx="10567630" cy="4184014"/>
          </a:xfrm>
        </p:spPr>
        <p:txBody>
          <a:bodyPr anchor="b"/>
          <a:lstStyle>
            <a:lvl1pPr>
              <a:defRPr sz="80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5967" y="6731215"/>
            <a:ext cx="10567630" cy="2200274"/>
          </a:xfrm>
        </p:spPr>
        <p:txBody>
          <a:bodyPr/>
          <a:lstStyle>
            <a:lvl1pPr marL="0" indent="0">
              <a:buNone/>
              <a:defRPr sz="3216">
                <a:solidFill>
                  <a:schemeClr val="tx1"/>
                </a:solidFill>
              </a:defRPr>
            </a:lvl1pPr>
            <a:lvl2pPr marL="612602" indent="0">
              <a:buNone/>
              <a:defRPr sz="2680">
                <a:solidFill>
                  <a:schemeClr val="tx1">
                    <a:tint val="75000"/>
                  </a:schemeClr>
                </a:solidFill>
              </a:defRPr>
            </a:lvl2pPr>
            <a:lvl3pPr marL="1225205" indent="0">
              <a:buNone/>
              <a:defRPr sz="2412">
                <a:solidFill>
                  <a:schemeClr val="tx1">
                    <a:tint val="75000"/>
                  </a:schemeClr>
                </a:solidFill>
              </a:defRPr>
            </a:lvl3pPr>
            <a:lvl4pPr marL="1837807" indent="0">
              <a:buNone/>
              <a:defRPr sz="2144">
                <a:solidFill>
                  <a:schemeClr val="tx1">
                    <a:tint val="75000"/>
                  </a:schemeClr>
                </a:solidFill>
              </a:defRPr>
            </a:lvl4pPr>
            <a:lvl5pPr marL="2450409" indent="0">
              <a:buNone/>
              <a:defRPr sz="2144">
                <a:solidFill>
                  <a:schemeClr val="tx1">
                    <a:tint val="75000"/>
                  </a:schemeClr>
                </a:solidFill>
              </a:defRPr>
            </a:lvl5pPr>
            <a:lvl6pPr marL="3063011" indent="0">
              <a:buNone/>
              <a:defRPr sz="2144">
                <a:solidFill>
                  <a:schemeClr val="tx1">
                    <a:tint val="75000"/>
                  </a:schemeClr>
                </a:solidFill>
              </a:defRPr>
            </a:lvl6pPr>
            <a:lvl7pPr marL="3675614" indent="0">
              <a:buNone/>
              <a:defRPr sz="2144">
                <a:solidFill>
                  <a:schemeClr val="tx1">
                    <a:tint val="75000"/>
                  </a:schemeClr>
                </a:solidFill>
              </a:defRPr>
            </a:lvl7pPr>
            <a:lvl8pPr marL="4288216" indent="0">
              <a:buNone/>
              <a:defRPr sz="2144">
                <a:solidFill>
                  <a:schemeClr val="tx1">
                    <a:tint val="75000"/>
                  </a:schemeClr>
                </a:solidFill>
              </a:defRPr>
            </a:lvl8pPr>
            <a:lvl9pPr marL="4900818" indent="0">
              <a:buNone/>
              <a:defRPr sz="21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893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42347" y="2677584"/>
            <a:ext cx="5207238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02740" y="2677584"/>
            <a:ext cx="5207238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966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3943" y="535519"/>
            <a:ext cx="1056763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3945" y="2465706"/>
            <a:ext cx="5183307" cy="1208404"/>
          </a:xfrm>
        </p:spPr>
        <p:txBody>
          <a:bodyPr anchor="b"/>
          <a:lstStyle>
            <a:lvl1pPr marL="0" indent="0">
              <a:buNone/>
              <a:defRPr sz="3216" b="1"/>
            </a:lvl1pPr>
            <a:lvl2pPr marL="612602" indent="0">
              <a:buNone/>
              <a:defRPr sz="2680" b="1"/>
            </a:lvl2pPr>
            <a:lvl3pPr marL="1225205" indent="0">
              <a:buNone/>
              <a:defRPr sz="2412" b="1"/>
            </a:lvl3pPr>
            <a:lvl4pPr marL="1837807" indent="0">
              <a:buNone/>
              <a:defRPr sz="2144" b="1"/>
            </a:lvl4pPr>
            <a:lvl5pPr marL="2450409" indent="0">
              <a:buNone/>
              <a:defRPr sz="2144" b="1"/>
            </a:lvl5pPr>
            <a:lvl6pPr marL="3063011" indent="0">
              <a:buNone/>
              <a:defRPr sz="2144" b="1"/>
            </a:lvl6pPr>
            <a:lvl7pPr marL="3675614" indent="0">
              <a:buNone/>
              <a:defRPr sz="2144" b="1"/>
            </a:lvl7pPr>
            <a:lvl8pPr marL="4288216" indent="0">
              <a:buNone/>
              <a:defRPr sz="2144" b="1"/>
            </a:lvl8pPr>
            <a:lvl9pPr marL="4900818" indent="0">
              <a:buNone/>
              <a:defRPr sz="214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43945" y="3674110"/>
            <a:ext cx="5183307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02740" y="2465706"/>
            <a:ext cx="5208834" cy="1208404"/>
          </a:xfrm>
        </p:spPr>
        <p:txBody>
          <a:bodyPr anchor="b"/>
          <a:lstStyle>
            <a:lvl1pPr marL="0" indent="0">
              <a:buNone/>
              <a:defRPr sz="3216" b="1"/>
            </a:lvl1pPr>
            <a:lvl2pPr marL="612602" indent="0">
              <a:buNone/>
              <a:defRPr sz="2680" b="1"/>
            </a:lvl2pPr>
            <a:lvl3pPr marL="1225205" indent="0">
              <a:buNone/>
              <a:defRPr sz="2412" b="1"/>
            </a:lvl3pPr>
            <a:lvl4pPr marL="1837807" indent="0">
              <a:buNone/>
              <a:defRPr sz="2144" b="1"/>
            </a:lvl4pPr>
            <a:lvl5pPr marL="2450409" indent="0">
              <a:buNone/>
              <a:defRPr sz="2144" b="1"/>
            </a:lvl5pPr>
            <a:lvl6pPr marL="3063011" indent="0">
              <a:buNone/>
              <a:defRPr sz="2144" b="1"/>
            </a:lvl6pPr>
            <a:lvl7pPr marL="3675614" indent="0">
              <a:buNone/>
              <a:defRPr sz="2144" b="1"/>
            </a:lvl7pPr>
            <a:lvl8pPr marL="4288216" indent="0">
              <a:buNone/>
              <a:defRPr sz="2144" b="1"/>
            </a:lvl8pPr>
            <a:lvl9pPr marL="4900818" indent="0">
              <a:buNone/>
              <a:defRPr sz="214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02740" y="3674110"/>
            <a:ext cx="5208834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179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0660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670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3943" y="670560"/>
            <a:ext cx="3951694" cy="2346960"/>
          </a:xfrm>
        </p:spPr>
        <p:txBody>
          <a:bodyPr anchor="b"/>
          <a:lstStyle>
            <a:lvl1pPr>
              <a:defRPr sz="428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208834" y="1448226"/>
            <a:ext cx="6202740" cy="7147983"/>
          </a:xfrm>
        </p:spPr>
        <p:txBody>
          <a:bodyPr/>
          <a:lstStyle>
            <a:lvl1pPr>
              <a:defRPr sz="4288"/>
            </a:lvl1pPr>
            <a:lvl2pPr>
              <a:defRPr sz="3752"/>
            </a:lvl2pPr>
            <a:lvl3pPr>
              <a:defRPr sz="3216"/>
            </a:lvl3pPr>
            <a:lvl4pPr>
              <a:defRPr sz="2680"/>
            </a:lvl4pPr>
            <a:lvl5pPr>
              <a:defRPr sz="2680"/>
            </a:lvl5pPr>
            <a:lvl6pPr>
              <a:defRPr sz="2680"/>
            </a:lvl6pPr>
            <a:lvl7pPr>
              <a:defRPr sz="2680"/>
            </a:lvl7pPr>
            <a:lvl8pPr>
              <a:defRPr sz="2680"/>
            </a:lvl8pPr>
            <a:lvl9pPr>
              <a:defRPr sz="268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3943" y="3017520"/>
            <a:ext cx="3951694" cy="5590329"/>
          </a:xfrm>
        </p:spPr>
        <p:txBody>
          <a:bodyPr/>
          <a:lstStyle>
            <a:lvl1pPr marL="0" indent="0">
              <a:buNone/>
              <a:defRPr sz="2144"/>
            </a:lvl1pPr>
            <a:lvl2pPr marL="612602" indent="0">
              <a:buNone/>
              <a:defRPr sz="1876"/>
            </a:lvl2pPr>
            <a:lvl3pPr marL="1225205" indent="0">
              <a:buNone/>
              <a:defRPr sz="1608"/>
            </a:lvl3pPr>
            <a:lvl4pPr marL="1837807" indent="0">
              <a:buNone/>
              <a:defRPr sz="1340"/>
            </a:lvl4pPr>
            <a:lvl5pPr marL="2450409" indent="0">
              <a:buNone/>
              <a:defRPr sz="1340"/>
            </a:lvl5pPr>
            <a:lvl6pPr marL="3063011" indent="0">
              <a:buNone/>
              <a:defRPr sz="1340"/>
            </a:lvl6pPr>
            <a:lvl7pPr marL="3675614" indent="0">
              <a:buNone/>
              <a:defRPr sz="1340"/>
            </a:lvl7pPr>
            <a:lvl8pPr marL="4288216" indent="0">
              <a:buNone/>
              <a:defRPr sz="1340"/>
            </a:lvl8pPr>
            <a:lvl9pPr marL="4900818" indent="0">
              <a:buNone/>
              <a:defRPr sz="134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7161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3943" y="670560"/>
            <a:ext cx="3951694" cy="2346960"/>
          </a:xfrm>
        </p:spPr>
        <p:txBody>
          <a:bodyPr anchor="b"/>
          <a:lstStyle>
            <a:lvl1pPr>
              <a:defRPr sz="428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208834" y="1448226"/>
            <a:ext cx="6202740" cy="7147983"/>
          </a:xfrm>
        </p:spPr>
        <p:txBody>
          <a:bodyPr anchor="t"/>
          <a:lstStyle>
            <a:lvl1pPr marL="0" indent="0">
              <a:buNone/>
              <a:defRPr sz="4288"/>
            </a:lvl1pPr>
            <a:lvl2pPr marL="612602" indent="0">
              <a:buNone/>
              <a:defRPr sz="3752"/>
            </a:lvl2pPr>
            <a:lvl3pPr marL="1225205" indent="0">
              <a:buNone/>
              <a:defRPr sz="3216"/>
            </a:lvl3pPr>
            <a:lvl4pPr marL="1837807" indent="0">
              <a:buNone/>
              <a:defRPr sz="2680"/>
            </a:lvl4pPr>
            <a:lvl5pPr marL="2450409" indent="0">
              <a:buNone/>
              <a:defRPr sz="2680"/>
            </a:lvl5pPr>
            <a:lvl6pPr marL="3063011" indent="0">
              <a:buNone/>
              <a:defRPr sz="2680"/>
            </a:lvl6pPr>
            <a:lvl7pPr marL="3675614" indent="0">
              <a:buNone/>
              <a:defRPr sz="2680"/>
            </a:lvl7pPr>
            <a:lvl8pPr marL="4288216" indent="0">
              <a:buNone/>
              <a:defRPr sz="2680"/>
            </a:lvl8pPr>
            <a:lvl9pPr marL="4900818" indent="0">
              <a:buNone/>
              <a:defRPr sz="268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3943" y="3017520"/>
            <a:ext cx="3951694" cy="5590329"/>
          </a:xfrm>
        </p:spPr>
        <p:txBody>
          <a:bodyPr/>
          <a:lstStyle>
            <a:lvl1pPr marL="0" indent="0">
              <a:buNone/>
              <a:defRPr sz="2144"/>
            </a:lvl1pPr>
            <a:lvl2pPr marL="612602" indent="0">
              <a:buNone/>
              <a:defRPr sz="1876"/>
            </a:lvl2pPr>
            <a:lvl3pPr marL="1225205" indent="0">
              <a:buNone/>
              <a:defRPr sz="1608"/>
            </a:lvl3pPr>
            <a:lvl4pPr marL="1837807" indent="0">
              <a:buNone/>
              <a:defRPr sz="1340"/>
            </a:lvl4pPr>
            <a:lvl5pPr marL="2450409" indent="0">
              <a:buNone/>
              <a:defRPr sz="1340"/>
            </a:lvl5pPr>
            <a:lvl6pPr marL="3063011" indent="0">
              <a:buNone/>
              <a:defRPr sz="1340"/>
            </a:lvl6pPr>
            <a:lvl7pPr marL="3675614" indent="0">
              <a:buNone/>
              <a:defRPr sz="1340"/>
            </a:lvl7pPr>
            <a:lvl8pPr marL="4288216" indent="0">
              <a:buNone/>
              <a:defRPr sz="1340"/>
            </a:lvl8pPr>
            <a:lvl9pPr marL="4900818" indent="0">
              <a:buNone/>
              <a:defRPr sz="134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980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42348" y="535519"/>
            <a:ext cx="1056763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2348" y="2677584"/>
            <a:ext cx="1056763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42347" y="9322649"/>
            <a:ext cx="2756773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58583" y="9322649"/>
            <a:ext cx="41351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53205" y="9322649"/>
            <a:ext cx="2756773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631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1225205" rtl="0" eaLnBrk="1" latinLnBrk="0" hangingPunct="1">
        <a:lnSpc>
          <a:spcPct val="90000"/>
        </a:lnSpc>
        <a:spcBef>
          <a:spcPct val="0"/>
        </a:spcBef>
        <a:buNone/>
        <a:defRPr sz="58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6301" indent="-306301" algn="l" defTabSz="1225205" rtl="0" eaLnBrk="1" latinLnBrk="0" hangingPunct="1">
        <a:lnSpc>
          <a:spcPct val="90000"/>
        </a:lnSpc>
        <a:spcBef>
          <a:spcPts val="1340"/>
        </a:spcBef>
        <a:buFont typeface="Arial" panose="020B0604020202020204" pitchFamily="34" charset="0"/>
        <a:buChar char="•"/>
        <a:defRPr sz="3752" kern="1200">
          <a:solidFill>
            <a:schemeClr val="tx1"/>
          </a:solidFill>
          <a:latin typeface="+mn-lt"/>
          <a:ea typeface="+mn-ea"/>
          <a:cs typeface="+mn-cs"/>
        </a:defRPr>
      </a:lvl1pPr>
      <a:lvl2pPr marL="918903" indent="-306301" algn="l" defTabSz="1225205" rtl="0" eaLnBrk="1" latinLnBrk="0" hangingPunct="1">
        <a:lnSpc>
          <a:spcPct val="90000"/>
        </a:lnSpc>
        <a:spcBef>
          <a:spcPts val="670"/>
        </a:spcBef>
        <a:buFont typeface="Arial" panose="020B0604020202020204" pitchFamily="34" charset="0"/>
        <a:buChar char="•"/>
        <a:defRPr sz="3216" kern="1200">
          <a:solidFill>
            <a:schemeClr val="tx1"/>
          </a:solidFill>
          <a:latin typeface="+mn-lt"/>
          <a:ea typeface="+mn-ea"/>
          <a:cs typeface="+mn-cs"/>
        </a:defRPr>
      </a:lvl2pPr>
      <a:lvl3pPr marL="1531506" indent="-306301" algn="l" defTabSz="1225205" rtl="0" eaLnBrk="1" latinLnBrk="0" hangingPunct="1">
        <a:lnSpc>
          <a:spcPct val="90000"/>
        </a:lnSpc>
        <a:spcBef>
          <a:spcPts val="670"/>
        </a:spcBef>
        <a:buFont typeface="Arial" panose="020B0604020202020204" pitchFamily="34" charset="0"/>
        <a:buChar char="•"/>
        <a:defRPr sz="2680" kern="1200">
          <a:solidFill>
            <a:schemeClr val="tx1"/>
          </a:solidFill>
          <a:latin typeface="+mn-lt"/>
          <a:ea typeface="+mn-ea"/>
          <a:cs typeface="+mn-cs"/>
        </a:defRPr>
      </a:lvl3pPr>
      <a:lvl4pPr marL="2144108" indent="-306301" algn="l" defTabSz="1225205" rtl="0" eaLnBrk="1" latinLnBrk="0" hangingPunct="1">
        <a:lnSpc>
          <a:spcPct val="90000"/>
        </a:lnSpc>
        <a:spcBef>
          <a:spcPts val="670"/>
        </a:spcBef>
        <a:buFont typeface="Arial" panose="020B0604020202020204" pitchFamily="34" charset="0"/>
        <a:buChar char="•"/>
        <a:defRPr sz="2412" kern="1200">
          <a:solidFill>
            <a:schemeClr val="tx1"/>
          </a:solidFill>
          <a:latin typeface="+mn-lt"/>
          <a:ea typeface="+mn-ea"/>
          <a:cs typeface="+mn-cs"/>
        </a:defRPr>
      </a:lvl4pPr>
      <a:lvl5pPr marL="2756710" indent="-306301" algn="l" defTabSz="1225205" rtl="0" eaLnBrk="1" latinLnBrk="0" hangingPunct="1">
        <a:lnSpc>
          <a:spcPct val="90000"/>
        </a:lnSpc>
        <a:spcBef>
          <a:spcPts val="670"/>
        </a:spcBef>
        <a:buFont typeface="Arial" panose="020B0604020202020204" pitchFamily="34" charset="0"/>
        <a:buChar char="•"/>
        <a:defRPr sz="2412" kern="1200">
          <a:solidFill>
            <a:schemeClr val="tx1"/>
          </a:solidFill>
          <a:latin typeface="+mn-lt"/>
          <a:ea typeface="+mn-ea"/>
          <a:cs typeface="+mn-cs"/>
        </a:defRPr>
      </a:lvl5pPr>
      <a:lvl6pPr marL="3369313" indent="-306301" algn="l" defTabSz="1225205" rtl="0" eaLnBrk="1" latinLnBrk="0" hangingPunct="1">
        <a:lnSpc>
          <a:spcPct val="90000"/>
        </a:lnSpc>
        <a:spcBef>
          <a:spcPts val="670"/>
        </a:spcBef>
        <a:buFont typeface="Arial" panose="020B0604020202020204" pitchFamily="34" charset="0"/>
        <a:buChar char="•"/>
        <a:defRPr sz="2412" kern="1200">
          <a:solidFill>
            <a:schemeClr val="tx1"/>
          </a:solidFill>
          <a:latin typeface="+mn-lt"/>
          <a:ea typeface="+mn-ea"/>
          <a:cs typeface="+mn-cs"/>
        </a:defRPr>
      </a:lvl6pPr>
      <a:lvl7pPr marL="3981915" indent="-306301" algn="l" defTabSz="1225205" rtl="0" eaLnBrk="1" latinLnBrk="0" hangingPunct="1">
        <a:lnSpc>
          <a:spcPct val="90000"/>
        </a:lnSpc>
        <a:spcBef>
          <a:spcPts val="670"/>
        </a:spcBef>
        <a:buFont typeface="Arial" panose="020B0604020202020204" pitchFamily="34" charset="0"/>
        <a:buChar char="•"/>
        <a:defRPr sz="2412" kern="1200">
          <a:solidFill>
            <a:schemeClr val="tx1"/>
          </a:solidFill>
          <a:latin typeface="+mn-lt"/>
          <a:ea typeface="+mn-ea"/>
          <a:cs typeface="+mn-cs"/>
        </a:defRPr>
      </a:lvl7pPr>
      <a:lvl8pPr marL="4594517" indent="-306301" algn="l" defTabSz="1225205" rtl="0" eaLnBrk="1" latinLnBrk="0" hangingPunct="1">
        <a:lnSpc>
          <a:spcPct val="90000"/>
        </a:lnSpc>
        <a:spcBef>
          <a:spcPts val="670"/>
        </a:spcBef>
        <a:buFont typeface="Arial" panose="020B0604020202020204" pitchFamily="34" charset="0"/>
        <a:buChar char="•"/>
        <a:defRPr sz="2412" kern="1200">
          <a:solidFill>
            <a:schemeClr val="tx1"/>
          </a:solidFill>
          <a:latin typeface="+mn-lt"/>
          <a:ea typeface="+mn-ea"/>
          <a:cs typeface="+mn-cs"/>
        </a:defRPr>
      </a:lvl8pPr>
      <a:lvl9pPr marL="5207119" indent="-306301" algn="l" defTabSz="1225205" rtl="0" eaLnBrk="1" latinLnBrk="0" hangingPunct="1">
        <a:lnSpc>
          <a:spcPct val="90000"/>
        </a:lnSpc>
        <a:spcBef>
          <a:spcPts val="670"/>
        </a:spcBef>
        <a:buFont typeface="Arial" panose="020B0604020202020204" pitchFamily="34" charset="0"/>
        <a:buChar char="•"/>
        <a:defRPr sz="241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25205" rtl="0" eaLnBrk="1" latinLnBrk="0" hangingPunct="1">
        <a:defRPr sz="2412" kern="1200">
          <a:solidFill>
            <a:schemeClr val="tx1"/>
          </a:solidFill>
          <a:latin typeface="+mn-lt"/>
          <a:ea typeface="+mn-ea"/>
          <a:cs typeface="+mn-cs"/>
        </a:defRPr>
      </a:lvl1pPr>
      <a:lvl2pPr marL="612602" algn="l" defTabSz="1225205" rtl="0" eaLnBrk="1" latinLnBrk="0" hangingPunct="1">
        <a:defRPr sz="2412" kern="1200">
          <a:solidFill>
            <a:schemeClr val="tx1"/>
          </a:solidFill>
          <a:latin typeface="+mn-lt"/>
          <a:ea typeface="+mn-ea"/>
          <a:cs typeface="+mn-cs"/>
        </a:defRPr>
      </a:lvl2pPr>
      <a:lvl3pPr marL="1225205" algn="l" defTabSz="1225205" rtl="0" eaLnBrk="1" latinLnBrk="0" hangingPunct="1">
        <a:defRPr sz="2412" kern="1200">
          <a:solidFill>
            <a:schemeClr val="tx1"/>
          </a:solidFill>
          <a:latin typeface="+mn-lt"/>
          <a:ea typeface="+mn-ea"/>
          <a:cs typeface="+mn-cs"/>
        </a:defRPr>
      </a:lvl3pPr>
      <a:lvl4pPr marL="1837807" algn="l" defTabSz="1225205" rtl="0" eaLnBrk="1" latinLnBrk="0" hangingPunct="1">
        <a:defRPr sz="2412" kern="1200">
          <a:solidFill>
            <a:schemeClr val="tx1"/>
          </a:solidFill>
          <a:latin typeface="+mn-lt"/>
          <a:ea typeface="+mn-ea"/>
          <a:cs typeface="+mn-cs"/>
        </a:defRPr>
      </a:lvl4pPr>
      <a:lvl5pPr marL="2450409" algn="l" defTabSz="1225205" rtl="0" eaLnBrk="1" latinLnBrk="0" hangingPunct="1">
        <a:defRPr sz="2412" kern="1200">
          <a:solidFill>
            <a:schemeClr val="tx1"/>
          </a:solidFill>
          <a:latin typeface="+mn-lt"/>
          <a:ea typeface="+mn-ea"/>
          <a:cs typeface="+mn-cs"/>
        </a:defRPr>
      </a:lvl5pPr>
      <a:lvl6pPr marL="3063011" algn="l" defTabSz="1225205" rtl="0" eaLnBrk="1" latinLnBrk="0" hangingPunct="1">
        <a:defRPr sz="2412" kern="1200">
          <a:solidFill>
            <a:schemeClr val="tx1"/>
          </a:solidFill>
          <a:latin typeface="+mn-lt"/>
          <a:ea typeface="+mn-ea"/>
          <a:cs typeface="+mn-cs"/>
        </a:defRPr>
      </a:lvl6pPr>
      <a:lvl7pPr marL="3675614" algn="l" defTabSz="1225205" rtl="0" eaLnBrk="1" latinLnBrk="0" hangingPunct="1">
        <a:defRPr sz="2412" kern="1200">
          <a:solidFill>
            <a:schemeClr val="tx1"/>
          </a:solidFill>
          <a:latin typeface="+mn-lt"/>
          <a:ea typeface="+mn-ea"/>
          <a:cs typeface="+mn-cs"/>
        </a:defRPr>
      </a:lvl7pPr>
      <a:lvl8pPr marL="4288216" algn="l" defTabSz="1225205" rtl="0" eaLnBrk="1" latinLnBrk="0" hangingPunct="1">
        <a:defRPr sz="2412" kern="1200">
          <a:solidFill>
            <a:schemeClr val="tx1"/>
          </a:solidFill>
          <a:latin typeface="+mn-lt"/>
          <a:ea typeface="+mn-ea"/>
          <a:cs typeface="+mn-cs"/>
        </a:defRPr>
      </a:lvl8pPr>
      <a:lvl9pPr marL="4900818" algn="l" defTabSz="1225205" rtl="0" eaLnBrk="1" latinLnBrk="0" hangingPunct="1">
        <a:defRPr sz="241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3E2455-AB72-4B24-B1F2-9F516DFB25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39602" y="3095631"/>
            <a:ext cx="11676333" cy="22448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>
              <a:lnSpc>
                <a:spcPct val="150000"/>
              </a:lnSpc>
              <a:buNone/>
            </a:pPr>
            <a:r>
              <a:rPr lang="en-US" sz="2010" b="1" dirty="0">
                <a:solidFill>
                  <a:srgbClr val="21212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anscriptome analysis of early stages of sorghum grain mold disease reveals defense regulators and metabolic pathways associated with resistance</a:t>
            </a:r>
          </a:p>
          <a:p>
            <a:pPr marL="0" indent="0" algn="ctr">
              <a:lnSpc>
                <a:spcPct val="150000"/>
              </a:lnSpc>
              <a:buNone/>
            </a:pPr>
            <a:endParaRPr lang="en-US" sz="2010" dirty="0"/>
          </a:p>
          <a:p>
            <a:pPr marL="0" indent="0" algn="ctr">
              <a:lnSpc>
                <a:spcPct val="150000"/>
              </a:lnSpc>
              <a:buNone/>
            </a:pPr>
            <a:r>
              <a:rPr lang="en-US" sz="2010" dirty="0"/>
              <a:t>Habte Nida, Sanghun Lee, Ying Li, Tesfaye Mengiste</a:t>
            </a:r>
          </a:p>
        </p:txBody>
      </p:sp>
    </p:spTree>
    <p:extLst>
      <p:ext uri="{BB962C8B-B14F-4D97-AF65-F5344CB8AC3E}">
        <p14:creationId xmlns:p14="http://schemas.microsoft.com/office/powerpoint/2010/main" val="1345524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8108427"/>
              </p:ext>
            </p:extLst>
          </p:nvPr>
        </p:nvGraphicFramePr>
        <p:xfrm>
          <a:off x="589721" y="1746138"/>
          <a:ext cx="5353050" cy="3733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1037368"/>
              </p:ext>
            </p:extLst>
          </p:nvPr>
        </p:nvGraphicFramePr>
        <p:xfrm>
          <a:off x="7142921" y="1746138"/>
          <a:ext cx="4572000" cy="3429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425948" y="1384212"/>
            <a:ext cx="3275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815375" y="1384212"/>
            <a:ext cx="3275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B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25948" y="5521976"/>
            <a:ext cx="3275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C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815375" y="5521976"/>
            <a:ext cx="3275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D</a:t>
            </a:r>
          </a:p>
        </p:txBody>
      </p:sp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43527652"/>
              </p:ext>
            </p:extLst>
          </p:nvPr>
        </p:nvGraphicFramePr>
        <p:xfrm>
          <a:off x="753494" y="5714061"/>
          <a:ext cx="5105400" cy="32048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70337840"/>
              </p:ext>
            </p:extLst>
          </p:nvPr>
        </p:nvGraphicFramePr>
        <p:xfrm>
          <a:off x="7022367" y="5714061"/>
          <a:ext cx="4572000" cy="34938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425948" y="445352"/>
            <a:ext cx="15414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Fig. S3</a:t>
            </a:r>
          </a:p>
        </p:txBody>
      </p:sp>
    </p:spTree>
    <p:extLst>
      <p:ext uri="{BB962C8B-B14F-4D97-AF65-F5344CB8AC3E}">
        <p14:creationId xmlns:p14="http://schemas.microsoft.com/office/powerpoint/2010/main" val="41559291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04</TotalTime>
  <Words>73</Words>
  <Application>Microsoft Office PowerPoint</Application>
  <PresentationFormat>Custom</PresentationFormat>
  <Paragraphs>1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Purdue University - AgI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bte Nida Chikssa</dc:creator>
  <cp:lastModifiedBy>Mengiste, Tesfaye</cp:lastModifiedBy>
  <cp:revision>23</cp:revision>
  <dcterms:created xsi:type="dcterms:W3CDTF">2020-10-05T21:04:59Z</dcterms:created>
  <dcterms:modified xsi:type="dcterms:W3CDTF">2021-02-09T14:47:06Z</dcterms:modified>
</cp:coreProperties>
</file>